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sldIdLst>
    <p:sldId id="256" r:id="rId2"/>
  </p:sldIdLst>
  <p:sldSz cx="8229600" cy="12801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1468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7220" y="2095078"/>
            <a:ext cx="6995160" cy="4456853"/>
          </a:xfrm>
        </p:spPr>
        <p:txBody>
          <a:bodyPr anchor="b"/>
          <a:lstStyle>
            <a:lvl1pPr algn="ctr"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6723804"/>
            <a:ext cx="6172200" cy="3090756"/>
          </a:xfrm>
        </p:spPr>
        <p:txBody>
          <a:bodyPr/>
          <a:lstStyle>
            <a:lvl1pPr marL="0" indent="0" algn="ctr">
              <a:buNone/>
              <a:defRPr sz="2160"/>
            </a:lvl1pPr>
            <a:lvl2pPr marL="411480" indent="0" algn="ctr">
              <a:buNone/>
              <a:defRPr sz="1800"/>
            </a:lvl2pPr>
            <a:lvl3pPr marL="822960" indent="0" algn="ctr">
              <a:buNone/>
              <a:defRPr sz="1620"/>
            </a:lvl3pPr>
            <a:lvl4pPr marL="1234440" indent="0" algn="ctr">
              <a:buNone/>
              <a:defRPr sz="1440"/>
            </a:lvl4pPr>
            <a:lvl5pPr marL="1645920" indent="0" algn="ctr">
              <a:buNone/>
              <a:defRPr sz="1440"/>
            </a:lvl5pPr>
            <a:lvl6pPr marL="2057400" indent="0" algn="ctr">
              <a:buNone/>
              <a:defRPr sz="1440"/>
            </a:lvl6pPr>
            <a:lvl7pPr marL="2468880" indent="0" algn="ctr">
              <a:buNone/>
              <a:defRPr sz="1440"/>
            </a:lvl7pPr>
            <a:lvl8pPr marL="2880360" indent="0" algn="ctr">
              <a:buNone/>
              <a:defRPr sz="1440"/>
            </a:lvl8pPr>
            <a:lvl9pPr marL="3291840" indent="0" algn="ctr">
              <a:buNone/>
              <a:defRPr sz="14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053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744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89308" y="681567"/>
            <a:ext cx="1774508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5785" y="681567"/>
            <a:ext cx="5220653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494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325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1499" y="3191514"/>
            <a:ext cx="7098030" cy="5325109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1499" y="8567000"/>
            <a:ext cx="7098030" cy="2800349"/>
          </a:xfrm>
        </p:spPr>
        <p:txBody>
          <a:bodyPr/>
          <a:lstStyle>
            <a:lvl1pPr marL="0" indent="0">
              <a:buNone/>
              <a:defRPr sz="2160">
                <a:solidFill>
                  <a:schemeClr val="tx1"/>
                </a:solidFill>
              </a:defRPr>
            </a:lvl1pPr>
            <a:lvl2pPr marL="41148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822960" indent="0">
              <a:buNone/>
              <a:defRPr sz="1620">
                <a:solidFill>
                  <a:schemeClr val="tx1">
                    <a:tint val="75000"/>
                  </a:schemeClr>
                </a:solidFill>
              </a:defRPr>
            </a:lvl3pPr>
            <a:lvl4pPr marL="12344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4pPr>
            <a:lvl5pPr marL="16459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5pPr>
            <a:lvl6pPr marL="205740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6pPr>
            <a:lvl7pPr marL="246888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7pPr>
            <a:lvl8pPr marL="288036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8pPr>
            <a:lvl9pPr marL="32918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165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5785" y="3407833"/>
            <a:ext cx="349758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235" y="3407833"/>
            <a:ext cx="349758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66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681570"/>
            <a:ext cx="7098030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858" y="3138171"/>
            <a:ext cx="3481506" cy="1537969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6858" y="4676140"/>
            <a:ext cx="3481506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66235" y="3138171"/>
            <a:ext cx="3498652" cy="1537969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66235" y="4676140"/>
            <a:ext cx="3498652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470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612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921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853440"/>
            <a:ext cx="2654260" cy="298704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98652" y="1843196"/>
            <a:ext cx="4166235" cy="9097433"/>
          </a:xfrm>
        </p:spPr>
        <p:txBody>
          <a:bodyPr/>
          <a:lstStyle>
            <a:lvl1pPr>
              <a:defRPr sz="2880"/>
            </a:lvl1pPr>
            <a:lvl2pPr>
              <a:defRPr sz="2520"/>
            </a:lvl2pPr>
            <a:lvl3pPr>
              <a:defRPr sz="216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3840480"/>
            <a:ext cx="2654260" cy="7114964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7036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853440"/>
            <a:ext cx="2654260" cy="298704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98652" y="1843196"/>
            <a:ext cx="4166235" cy="9097433"/>
          </a:xfrm>
        </p:spPr>
        <p:txBody>
          <a:bodyPr anchor="t"/>
          <a:lstStyle>
            <a:lvl1pPr marL="0" indent="0">
              <a:buNone/>
              <a:defRPr sz="2880"/>
            </a:lvl1pPr>
            <a:lvl2pPr marL="411480" indent="0">
              <a:buNone/>
              <a:defRPr sz="2520"/>
            </a:lvl2pPr>
            <a:lvl3pPr marL="822960" indent="0">
              <a:buNone/>
              <a:defRPr sz="216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3840480"/>
            <a:ext cx="2654260" cy="7114964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227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5785" y="681570"/>
            <a:ext cx="7098030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5785" y="3407833"/>
            <a:ext cx="7098030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5785" y="11865189"/>
            <a:ext cx="185166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6055" y="11865189"/>
            <a:ext cx="277749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12155" y="11865189"/>
            <a:ext cx="185166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092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822960" rtl="0" eaLnBrk="1" latinLnBrk="0" hangingPunct="1">
        <a:lnSpc>
          <a:spcPct val="90000"/>
        </a:lnSpc>
        <a:spcBef>
          <a:spcPct val="0"/>
        </a:spcBef>
        <a:buNone/>
        <a:defRPr sz="39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5740" indent="-205740" algn="l" defTabSz="82296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85166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26314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30861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4975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5DF41B57-02CF-20D0-D45E-0FEA3659F07E}"/>
              </a:ext>
            </a:extLst>
          </p:cNvPr>
          <p:cNvCxnSpPr>
            <a:cxnSpLocks/>
          </p:cNvCxnSpPr>
          <p:nvPr/>
        </p:nvCxnSpPr>
        <p:spPr>
          <a:xfrm>
            <a:off x="-9938" y="2987204"/>
            <a:ext cx="8229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C00148E3-49C2-A642-5B3C-7E3B62A9BF64}"/>
              </a:ext>
            </a:extLst>
          </p:cNvPr>
          <p:cNvSpPr txBox="1"/>
          <p:nvPr/>
        </p:nvSpPr>
        <p:spPr>
          <a:xfrm>
            <a:off x="118514" y="2984050"/>
            <a:ext cx="721783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42437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art failure hospitalization excluding studies with higher risk of bias</a:t>
            </a:r>
            <a:endParaRPr lang="en-US" altLang="en-US" sz="1200" dirty="0">
              <a:latin typeface="Arial" panose="020B0604020202020204" pitchFamily="34" charset="0"/>
            </a:endParaRP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A0022CA1-B89E-F6AD-D6F9-73CE3C559B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" y="3269558"/>
            <a:ext cx="8219662" cy="257379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F91AEFE-3443-EFB3-EAF0-CFAC73185EB3}"/>
              </a:ext>
            </a:extLst>
          </p:cNvPr>
          <p:cNvSpPr txBox="1"/>
          <p:nvPr/>
        </p:nvSpPr>
        <p:spPr>
          <a:xfrm>
            <a:off x="65464" y="5826504"/>
            <a:ext cx="721783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42437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art failure hospitalization including only studies with &gt;100 sample size at each group</a:t>
            </a:r>
            <a:endParaRPr lang="en-US" altLang="en-US" sz="1200" dirty="0">
              <a:latin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78C2B33-17B1-2067-3491-496BB5CD4A8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7" y="6108693"/>
            <a:ext cx="8223031" cy="2590800"/>
          </a:xfrm>
          <a:prstGeom prst="rect">
            <a:avLst/>
          </a:prstGeom>
        </p:spPr>
      </p:pic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C76E1B14-3B26-E017-A8E8-A32FDBAC320A}"/>
              </a:ext>
            </a:extLst>
          </p:cNvPr>
          <p:cNvCxnSpPr>
            <a:cxnSpLocks/>
          </p:cNvCxnSpPr>
          <p:nvPr/>
        </p:nvCxnSpPr>
        <p:spPr>
          <a:xfrm>
            <a:off x="-9941" y="8719750"/>
            <a:ext cx="8229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5BC88547-620F-9EA5-0055-609A39B86792}"/>
              </a:ext>
            </a:extLst>
          </p:cNvPr>
          <p:cNvCxnSpPr>
            <a:cxnSpLocks/>
          </p:cNvCxnSpPr>
          <p:nvPr/>
        </p:nvCxnSpPr>
        <p:spPr>
          <a:xfrm>
            <a:off x="6569" y="5843349"/>
            <a:ext cx="8229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Picture 5">
            <a:extLst>
              <a:ext uri="{FF2B5EF4-FFF2-40B4-BE49-F238E27FC236}">
                <a16:creationId xmlns:a16="http://schemas.microsoft.com/office/drawing/2014/main" id="{C42EA947-3333-87E2-75A8-D1E42FAF628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23261"/>
            <a:ext cx="8219662" cy="25908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D3A064E-6F56-10C0-5F4F-610529FE4CC2}"/>
              </a:ext>
            </a:extLst>
          </p:cNvPr>
          <p:cNvSpPr txBox="1"/>
          <p:nvPr/>
        </p:nvSpPr>
        <p:spPr>
          <a:xfrm>
            <a:off x="118514" y="13633"/>
            <a:ext cx="711173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42437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art failure hospitalization excluding the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tudy with the highest contribution to heterogeneity</a:t>
            </a:r>
            <a:endParaRPr lang="en-US" altLang="en-US" sz="1200" b="1" dirty="0">
              <a:latin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C7228CA-3CEF-ABD7-89A9-6DAAB1487CB0}"/>
              </a:ext>
            </a:extLst>
          </p:cNvPr>
          <p:cNvSpPr txBox="1"/>
          <p:nvPr/>
        </p:nvSpPr>
        <p:spPr>
          <a:xfrm>
            <a:off x="188990" y="8740008"/>
            <a:ext cx="721783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42437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art failure hospitalization including only studies with </a:t>
            </a:r>
            <a:r>
              <a:rPr lang="en-US" sz="1200" b="1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llow-up &gt;3 months </a:t>
            </a:r>
            <a:endParaRPr lang="en-US" altLang="en-US" sz="1200" b="1" dirty="0">
              <a:latin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567DCE6B-C555-D35A-81C5-2652A731F89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9" y="9005351"/>
            <a:ext cx="8213090" cy="259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39744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308</TotalTime>
  <Words>47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y ghonim</dc:creator>
  <cp:lastModifiedBy>Mohamed Atef</cp:lastModifiedBy>
  <cp:revision>23</cp:revision>
  <dcterms:created xsi:type="dcterms:W3CDTF">2022-12-15T05:23:43Z</dcterms:created>
  <dcterms:modified xsi:type="dcterms:W3CDTF">2023-04-22T20:04:59Z</dcterms:modified>
</cp:coreProperties>
</file>